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21540-16EF-477F-BC07-9FA89EB678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D6F48-A661-463D-A058-7EBC99937E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2B630-05D9-4985-B2C5-6FDD553D10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370D9-656C-43C3-B40B-00B37E79C6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02FAD-4BC3-43DC-AECF-E5D30E2C76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FDB83-C763-4F91-B895-77025B5C85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30304-C923-4C98-9241-7ED1AA760D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02640-182D-42B7-B778-1E30996A9B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5FADD-D760-4EFB-BC05-D9FAC7742B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214A3-2EFF-474D-A248-0A97FE9252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D83BF-8FDD-4A93-AC1B-A338961EE4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0D3F7-61D1-49F1-BDAB-D9CE0B76A2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F660CC-AF38-473F-AF64-7B84AB690A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1219320"/>
            <a:ext cx="9144000" cy="18381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12480" y="152280"/>
            <a:ext cx="5693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0172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9320" y="874800"/>
            <a:ext cx="241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roup 3 in N-term tre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248520" y="2666880"/>
            <a:ext cx="1066680" cy="3049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781680" y="29718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772680" y="3352680"/>
            <a:ext cx="1988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rthologous cluster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p_1729/ lp_1730/ lp_17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197760" y="156204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426360" y="18288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210360" y="237492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210360" y="26668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781680" y="350532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11120" y="1295280"/>
            <a:ext cx="62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p_01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11480" y="16606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sl_12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11480" y="188928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ms_01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11120" y="213372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ru_11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11120" y="2422440"/>
            <a:ext cx="69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be_03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235960" y="267984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pep_05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2"/>
          <a:srcRect l="4446" t="14348" r="32226" b="83402"/>
          <a:stretch/>
        </p:blipFill>
        <p:spPr>
          <a:xfrm>
            <a:off x="152280" y="3505320"/>
            <a:ext cx="5324760" cy="147456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457200" y="3809880"/>
            <a:ext cx="5181480" cy="107496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781680" y="4572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861600" y="38088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" descr=""/>
          <p:cNvPicPr/>
          <p:nvPr/>
        </p:nvPicPr>
        <p:blipFill>
          <a:blip r:embed="rId1"/>
          <a:stretch/>
        </p:blipFill>
        <p:spPr>
          <a:xfrm>
            <a:off x="282600" y="1009800"/>
            <a:ext cx="8785080" cy="2114280"/>
          </a:xfrm>
          <a:prstGeom prst="rect">
            <a:avLst/>
          </a:prstGeom>
          <a:ln w="0">
            <a:noFill/>
          </a:ln>
        </p:spPr>
      </p:pic>
      <p:sp>
        <p:nvSpPr>
          <p:cNvPr id="186" name=""/>
          <p:cNvSpPr/>
          <p:nvPr/>
        </p:nvSpPr>
        <p:spPr>
          <a:xfrm>
            <a:off x="158760" y="228600"/>
            <a:ext cx="452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70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8400" y="1009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c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81000" y="2090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99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8400" y="1514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c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81000" y="1814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99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81000" y="23907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99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5467320" y="1009800"/>
            <a:ext cx="0" cy="7272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5396040" y="1009800"/>
            <a:ext cx="0" cy="7272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5479920" y="162396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5396040" y="16192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492880" y="190008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5433840" y="190008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6259680" y="191304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500800" y="214776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442120" y="214776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5827680" y="2160720"/>
            <a:ext cx="0" cy="7272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5827680" y="244944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5467320" y="2449440"/>
            <a:ext cx="0" cy="73080"/>
          </a:xfrm>
          <a:prstGeom prst="line">
            <a:avLst/>
          </a:prstGeom>
          <a:ln w="381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5398920" y="99684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4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967280" y="99684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4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5398920" y="12603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4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5411520" y="15289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8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967280" y="16207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8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445000" y="203184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262560" y="201780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967280" y="18748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5850000" y="21160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85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5457600" y="23065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8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967280" y="21621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8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5398920" y="26668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3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5398920" y="247500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5897520" y="247500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6404400" y="22860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6172200" y="3808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8231400" y="228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c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" descr=""/>
          <p:cNvPicPr/>
          <p:nvPr/>
        </p:nvPicPr>
        <p:blipFill>
          <a:blip r:embed="rId1"/>
          <a:stretch/>
        </p:blipFill>
        <p:spPr>
          <a:xfrm>
            <a:off x="179280" y="1620720"/>
            <a:ext cx="8785440" cy="3219480"/>
          </a:xfrm>
          <a:prstGeom prst="rect">
            <a:avLst/>
          </a:prstGeom>
          <a:ln w="0">
            <a:noFill/>
          </a:ln>
        </p:spPr>
      </p:pic>
      <p:sp>
        <p:nvSpPr>
          <p:cNvPr id="222" name=""/>
          <p:cNvSpPr/>
          <p:nvPr/>
        </p:nvSpPr>
        <p:spPr>
          <a:xfrm>
            <a:off x="4859280" y="1700280"/>
            <a:ext cx="1368360" cy="28728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859280" y="2249640"/>
            <a:ext cx="1368360" cy="28728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859280" y="3400560"/>
            <a:ext cx="1368360" cy="50328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716360" y="1960560"/>
            <a:ext cx="1368360" cy="28728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4859280" y="2579760"/>
            <a:ext cx="1368360" cy="79200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859280" y="3932280"/>
            <a:ext cx="1368360" cy="93672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5725440" y="14558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5725080" y="1816200"/>
            <a:ext cx="77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OE 10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739840" y="2147760"/>
            <a:ext cx="73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BE 18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726520" y="243540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14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726160" y="26798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N 07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5726160" y="294012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R 18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725800" y="322740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RE 12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724720" y="3471840"/>
            <a:ext cx="157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CA 0407 and LSE 04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725440" y="38037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3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5725440" y="40924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7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5726160" y="433692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H 07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5810400" y="139860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4859280" y="142704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5162400" y="194472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4903920" y="224784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133960" y="339876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4873680" y="365760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838840" y="469584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838840" y="440856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5838840" y="404820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810400" y="322740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824440" y="301140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824440" y="26938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56680" y="260280"/>
            <a:ext cx="473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79  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7166520" y="22860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6934320" y="3808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4" name="" descr=""/>
          <p:cNvPicPr/>
          <p:nvPr/>
        </p:nvPicPr>
        <p:blipFill>
          <a:blip r:embed="rId1"/>
          <a:srcRect l="51546" t="0" r="0" b="1718"/>
          <a:stretch/>
        </p:blipFill>
        <p:spPr>
          <a:xfrm>
            <a:off x="1752480" y="1143000"/>
            <a:ext cx="6985080" cy="1241280"/>
          </a:xfrm>
          <a:prstGeom prst="rect">
            <a:avLst/>
          </a:prstGeom>
          <a:ln w="0">
            <a:noFill/>
          </a:ln>
        </p:spPr>
      </p:pic>
      <p:sp>
        <p:nvSpPr>
          <p:cNvPr id="255" name=""/>
          <p:cNvSpPr/>
          <p:nvPr/>
        </p:nvSpPr>
        <p:spPr>
          <a:xfrm>
            <a:off x="222840" y="1306440"/>
            <a:ext cx="155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. plant (LPL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42640" y="1719360"/>
            <a:ext cx="157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. pent (PEP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546280" y="106992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122280" y="11174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547360" y="11174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987360" y="11174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8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5139720" y="1114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122280" y="1690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4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547360" y="1690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4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987360" y="1690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121200" y="1071720"/>
            <a:ext cx="0" cy="7272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770280" y="10684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4849920" y="1071720"/>
            <a:ext cx="0" cy="7272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2546280" y="171612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121200" y="171756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770280" y="171756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56680" y="260280"/>
            <a:ext cx="473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88  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7166520" y="22860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6934320" y="380880"/>
            <a:ext cx="0" cy="73080"/>
          </a:xfrm>
          <a:prstGeom prst="line">
            <a:avLst/>
          </a:prstGeom>
          <a:ln w="38160">
            <a:solidFill>
              <a:srgbClr val="99cc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"/>
          <p:cNvSpPr/>
          <p:nvPr/>
        </p:nvSpPr>
        <p:spPr>
          <a:xfrm>
            <a:off x="4191120" y="228600"/>
            <a:ext cx="4572000" cy="50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26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2602-LactobacillusplantarumWCFS1,LPL_2322719_232178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CTGGTACCGGTTTCAC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AG00762-Streptococcusagalactiae2603V/R,NC_004116_781580_7823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ATGGAACGGGTTCCAG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1554-Lactobacillussakeisubsp.sakei23K,CR936503_1526189_15270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CTGGGACGCGTTTC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2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221-LactobacillusplantarumWCFS1,LPL_2871483_287048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TGGAAACGATTCC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E01604-LactobacilluscaseiATCC334,NC_008526_2095700_20947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TGAAATCGATTCC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53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533_1-LactobacillusplantarumWCFS1,LPL_3150332_31517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GTGTAAACGTTTAC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533_2-LactobacillusplantarumWCFS1,LPL_3150332_31517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TGTAAACGTTTACG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OON00187_1-OenococcusoeniPSU-1,NC_008528_40575_39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CAGTAAACGTTTACT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OON00187_2-OenococcusoeniPSU-1,NC_008528_40575_39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TGTAAACGTTTACTG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OON00187_3-OenococcusoeniPSU-1,NC_008528_40575_39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TGTAAACGTTTACT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RE01125-LactobacillusreuteriJCM1112,AAOV01000033_9204_75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AGTAAACGTTTAC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E01514-LeuconostocmesenteroidesATCC-8293(JGI),scaffold_57_4727_63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TGTAAACGTTTACGC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6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627-LactobacillusplantarumWCFS1,LPL_3242794_32411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AGCAAACGTTTGCT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BE02143_1-LactobacillusbrevisATCC367,NC_008497_2145014_21463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CACAAACGTTTGC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BE02143_2-LactobacillusbrevisATCC367,NC_008497_2145014_21463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TGCAAACGTTTGTG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HA00075-StaphylococcushaemolyticusJCSC1435,NC_007168_82213_804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CTCAAACGTTTGAG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66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660-LactobacillusplantarumWCFS1,LPL_3281249_328033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ATAAAACGTTTTA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EF00346-EnterococcusfaecalisV583,NC_004668_2834340_283343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CTAAAACGTTTTA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0437-PediococcuspentosaceusATCC25745,NC_008525_1674652_16737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ATAAAACGTTTTAAA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EFA02850-EnterococcusfaeciumDO(JGI),Contig0036_2675_17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CTAAAACGTTTTA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0196-Lactobacillussakeisubsp.sakei23K,CR936503_193092_1939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GTAAAACGTTTTAC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AM00277-StaphylococcusaureusMu50,NC_002758_315158_3142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GGTAAAACGTTTTAC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0" y="228600"/>
            <a:ext cx="4572000" cy="640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1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1282-Lactobacillussalivariussubsp.salivariusUCC118(IG-157),NC_007929_1322719_13213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CGCAAACGGTTGC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0536-PediococcuspentosaceusATCC25745,NC_008525_974542_9732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GTGCAAACGCTTGCAC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BE00365-LactobacillusbrevisATCC367,NC_008497_381212_3825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GCGCAATCGGTTGC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1729-LactobacillusplantarumWCFS1,LPL_1565021_15663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ACGCAAACGCTTGC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S00144-LeuconostocmesenteroidesATCC8293,NC_008531_891162_8925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GGGCAAACGCTTCC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1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0175-LactobacillusplantarumWCFS1,LPL_151222_1524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TGTTAACGTTAAC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O02124-ListeriamonocytogenesEGD-e,NC_003210_2208362_22071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TTGTAAACGCTTTCG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BS03456-Bacillussubtilis168,BACSU_3554836_35535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TGTTATCGGTAAC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BLH00606-BacilluslicheniformisDSM13,NC_006322_662015_6632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TGTTACCGGTAACA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1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0187-LactobacillusplantarumWCFS1,LPL_167690_1691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ACGATTGA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1800-PediococcuspentosaceusATCC25745,NC_008525_574186_5756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ACGATTGA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EF00492-EnterococcusfaecalisV583,NC_004668_1557238_15586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TATACGTTTGAC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AG01646-Streptococcusagalactiae2603V/R,NC_004116_1691408_16928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GCGTTTGA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PM01882-StreptococcuspyogenesM18MGAS8232,NC_003485_1562572_15640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GCGTTTAA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MN00134-StreptococcusmutansUA159,Contig2_1741398_174283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TCGTTTTA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1793-Lactobacillussakeisubsp.sakei23K,CR936503_1779379_178085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ACGATTAT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065-Lactobacillussalivariussubsp.salivariusUCC118(IG-157),NC_007929_81998_805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TATACGATTGACA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AC00383-LactobacillusacidophilusNCFM,NC_006814_375108_37365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TCGTTTGACA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JO00518-LactobacillusjohnsoniiNCC533,NC_005362_1861776_186324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GCGCTTAT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GA00093-LactobacillusgasseriATCC-33323(JGI),NC_008530_1764253_17657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GCGCTTATCA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TH00541-StreptococcusthermophilusCNRZ1066(IG-40),NC_006449_1552093_155353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GTCAAACGTTTAGC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22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2256-LactobacillusplantarumWCFS1,LPL_2040324_20393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ATGAAAGCGATTT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BE01171-LactobacillusbrevisATCC367,NC_008497_1178074_11770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CGAAAACGTTTT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E00755-LactobacilluscaseiATCC334,NC_008526_804301_8052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AGTAAAACGCTTGC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420-Lactobacillussalivariussubsp.salivariusUCC118(IG-157),NC_007929_463530_46453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ATGAAACGCTTG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E00420-LeuconostocmesenteroidesATCC-8293(JGI),scaffold_19_12466_1146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TTGTAAGCGTTTG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DB00875-Lactobacillusdelbrueckiisubsp.bulgaricusATCC11842(IG-98),NC_008054_1368486_13674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CTGTAAGCGATTGCAC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JO00491-LactobacillusjohnsoniiNCC533,NC_005362_545423_5464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TCGTAAACGGTTG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GA00804-LactobacillusgasseriATCC-33323(JGI),NC_008530_462533_4635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TCGTAAACGGTTG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AC00414-LactobacillusacidophilusNCFM,NC_006814_405409_40640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CTGTAAACGTTTGC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PE01697-PediococcuspentosaceusATCC25745(JGI),scaffold_9_21906_2090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TGATAACGTATTCAT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7848720" y="873000"/>
            <a:ext cx="1295280" cy="594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4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S0082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CATTTACTAATT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S0082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AATTTAGTAATG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MS0082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CATTTGACTAATGT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ATTTTAGTAAAAC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ATATTTAGTAATT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4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E004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TTTTTAGTAAAATAA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E004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TTTTTAGTAAAAGGA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GTAAAACTA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GTTTTAGTTAAACTT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OOE010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GGAATTTAGTAAAT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RE012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GTATTTAGTAAAAGTT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07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CATTTACTAAAA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07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TTTTTAGTAAATG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07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ATTTTACTAAACATT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K007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TGTTTAGTAAAATG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3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GTTTACTAAAAAG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3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CTTTTTAGTAAAC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3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TTTTTAGTAAATTTT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SL003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ATTTACTAAAA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BE0185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CTTTACTAAAAA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MN014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CTAAATT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MN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AATTTAGTAAAA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MN014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TTTTTACTAAAA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MN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GTAAAA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N007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GTAAAAT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N007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ATTTTACTAAAA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N007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CTTTTTACTAAAAT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N007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GTAAAAAG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TH0074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TATTTTACTAAAAA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STH007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TTTTTTAGTAAAAT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6705720" y="5308560"/>
            <a:ext cx="10666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34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15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CTAAAAAA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15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CTAATTTACTAAAATA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ATTTTACTAAAAAT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04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TATTTACTCAATCC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PEP004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ATTTTAACTAAAAT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8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AAGTTTTACTCAACTT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&gt;LPL0348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TCTTTTAACTAAAAG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826560" y="-39600"/>
            <a:ext cx="622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upstream sites to create TF-specific binding motif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76320" y="1295280"/>
            <a:ext cx="9067680" cy="26672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312480" y="152280"/>
            <a:ext cx="569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0173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248520" y="13716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273720" y="191772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781680" y="3289320"/>
            <a:ext cx="0" cy="76320"/>
          </a:xfrm>
          <a:prstGeom prst="line">
            <a:avLst/>
          </a:prstGeom>
          <a:ln w="38160">
            <a:solidFill>
              <a:srgbClr val="8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273720" y="218448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553080" y="35812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" descr=""/>
          <p:cNvPicPr/>
          <p:nvPr/>
        </p:nvPicPr>
        <p:blipFill>
          <a:blip r:embed="rId2"/>
          <a:srcRect l="4446" t="40932" r="29953" b="56120"/>
          <a:stretch/>
        </p:blipFill>
        <p:spPr>
          <a:xfrm>
            <a:off x="304920" y="4191120"/>
            <a:ext cx="3047760" cy="106668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838080" y="4292640"/>
            <a:ext cx="2895840" cy="88884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781680" y="3009960"/>
            <a:ext cx="0" cy="76320"/>
          </a:xfrm>
          <a:prstGeom prst="line">
            <a:avLst/>
          </a:prstGeom>
          <a:ln w="38160">
            <a:solidFill>
              <a:srgbClr val="8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7162920" y="2743200"/>
            <a:ext cx="0" cy="76320"/>
          </a:xfrm>
          <a:prstGeom prst="line">
            <a:avLst/>
          </a:prstGeom>
          <a:ln w="38160">
            <a:solidFill>
              <a:srgbClr val="8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807240" y="2463840"/>
            <a:ext cx="0" cy="76320"/>
          </a:xfrm>
          <a:prstGeom prst="line">
            <a:avLst/>
          </a:prstGeom>
          <a:ln w="38160">
            <a:solidFill>
              <a:srgbClr val="8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208480" y="1181160"/>
            <a:ext cx="62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p_01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173640" y="1177920"/>
            <a:ext cx="62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ff"/>
                </a:solidFill>
                <a:latin typeface="Arial"/>
              </a:rPr>
              <a:t>lp_01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324480" y="6858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404400" y="60948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312480" y="152280"/>
            <a:ext cx="5693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0188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" descr=""/>
          <p:cNvPicPr/>
          <p:nvPr/>
        </p:nvPicPr>
        <p:blipFill>
          <a:blip r:embed="rId1"/>
          <a:srcRect l="4446" t="67675" r="29953" b="26641"/>
          <a:stretch/>
        </p:blipFill>
        <p:spPr>
          <a:xfrm>
            <a:off x="304920" y="4495680"/>
            <a:ext cx="3047760" cy="205740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609480" y="4572000"/>
            <a:ext cx="2895840" cy="19051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781680" y="3808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861600" y="30492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"/>
          <p:cNvGrpSpPr/>
          <p:nvPr/>
        </p:nvGrpSpPr>
        <p:grpSpPr>
          <a:xfrm>
            <a:off x="380880" y="685800"/>
            <a:ext cx="8077320" cy="3657600"/>
            <a:chOff x="380880" y="685800"/>
            <a:chExt cx="8077320" cy="3657600"/>
          </a:xfrm>
        </p:grpSpPr>
        <p:pic>
          <p:nvPicPr>
            <p:cNvPr id="84" name="" descr=""/>
            <p:cNvPicPr/>
            <p:nvPr/>
          </p:nvPicPr>
          <p:blipFill>
            <a:blip r:embed="rId2"/>
            <a:srcRect l="0" t="0" r="0" b="15862"/>
            <a:stretch/>
          </p:blipFill>
          <p:spPr>
            <a:xfrm>
              <a:off x="380880" y="849240"/>
              <a:ext cx="8077320" cy="343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"/>
            <p:cNvSpPr/>
            <p:nvPr/>
          </p:nvSpPr>
          <p:spPr>
            <a:xfrm>
              <a:off x="5193360" y="903960"/>
              <a:ext cx="0" cy="54360"/>
            </a:xfrm>
            <a:prstGeom prst="line">
              <a:avLst/>
            </a:prstGeom>
            <a:ln w="38160">
              <a:solidFill>
                <a:srgbClr val="0000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193360" y="1067760"/>
              <a:ext cx="0" cy="54360"/>
            </a:xfrm>
            <a:prstGeom prst="line">
              <a:avLst/>
            </a:prstGeom>
            <a:ln w="38160">
              <a:solidFill>
                <a:srgbClr val="00808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193360" y="1285920"/>
              <a:ext cx="0" cy="54360"/>
            </a:xfrm>
            <a:prstGeom prst="line">
              <a:avLst/>
            </a:prstGeom>
            <a:ln w="38160">
              <a:solidFill>
                <a:srgbClr val="0000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193360" y="1449720"/>
              <a:ext cx="0" cy="54360"/>
            </a:xfrm>
            <a:prstGeom prst="line">
              <a:avLst/>
            </a:prstGeom>
            <a:ln w="38160">
              <a:solidFill>
                <a:srgbClr val="00808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092560" y="685800"/>
              <a:ext cx="201600" cy="3657600"/>
            </a:xfrm>
            <a:prstGeom prst="rect">
              <a:avLst/>
            </a:prstGeom>
            <a:solidFill>
              <a:srgbClr val="99ccff">
                <a:alpha val="19000"/>
              </a:srgbClr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" descr=""/>
          <p:cNvPicPr/>
          <p:nvPr/>
        </p:nvPicPr>
        <p:blipFill>
          <a:blip r:embed="rId1"/>
          <a:stretch/>
        </p:blipFill>
        <p:spPr>
          <a:xfrm>
            <a:off x="0" y="228600"/>
            <a:ext cx="9144000" cy="625788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294840" y="36360"/>
            <a:ext cx="534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2256    CcpA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867280" y="35568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880240" y="227340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867280" y="337824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867280" y="365760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880240" y="393696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867280" y="502920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867280" y="533412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867280" y="563868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880240" y="591804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854680" y="474984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176280" y="6491160"/>
            <a:ext cx="595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Lactobacill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Leuconostoc mesenteroid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52280" y="6477120"/>
            <a:ext cx="228600" cy="22860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60800" y="641520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" descr=""/>
          <p:cNvPicPr/>
          <p:nvPr/>
        </p:nvPicPr>
        <p:blipFill>
          <a:blip r:embed="rId1"/>
          <a:stretch/>
        </p:blipFill>
        <p:spPr>
          <a:xfrm>
            <a:off x="0" y="1600200"/>
            <a:ext cx="9144000" cy="266688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>
            <a:off x="5791320" y="1371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H="1">
            <a:off x="5257800" y="1371600"/>
            <a:ext cx="533520" cy="1143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702400" y="950760"/>
            <a:ext cx="116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ydrol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36160" y="304920"/>
            <a:ext cx="5693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2602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092560" y="327672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092560" y="24382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334120" y="16002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" descr=""/>
          <p:cNvPicPr/>
          <p:nvPr/>
        </p:nvPicPr>
        <p:blipFill>
          <a:blip r:embed="rId2"/>
          <a:srcRect l="7727" t="92733" r="29953" b="3899"/>
          <a:stretch/>
        </p:blipFill>
        <p:spPr>
          <a:xfrm>
            <a:off x="304920" y="4648320"/>
            <a:ext cx="2895480" cy="1218960"/>
          </a:xfrm>
          <a:prstGeom prst="rect">
            <a:avLst/>
          </a:prstGeom>
          <a:ln w="0">
            <a:noFill/>
          </a:ln>
        </p:spPr>
      </p:pic>
      <p:sp>
        <p:nvSpPr>
          <p:cNvPr id="114" name=""/>
          <p:cNvSpPr/>
          <p:nvPr/>
        </p:nvSpPr>
        <p:spPr>
          <a:xfrm>
            <a:off x="635040" y="4775040"/>
            <a:ext cx="2895480" cy="9907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7010280" y="6858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090200" y="60948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"/>
          <p:cNvSpPr/>
          <p:nvPr/>
        </p:nvSpPr>
        <p:spPr>
          <a:xfrm>
            <a:off x="160200" y="152280"/>
            <a:ext cx="569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221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0" y="1295280"/>
            <a:ext cx="9144000" cy="1009800"/>
          </a:xfrm>
          <a:prstGeom prst="rect">
            <a:avLst/>
          </a:prstGeom>
          <a:ln w="0">
            <a:noFill/>
          </a:ln>
        </p:spPr>
      </p:pic>
      <p:sp>
        <p:nvSpPr>
          <p:cNvPr id="119" name=""/>
          <p:cNvSpPr/>
          <p:nvPr/>
        </p:nvSpPr>
        <p:spPr>
          <a:xfrm>
            <a:off x="5090760" y="15159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106600" y="18288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166800" y="17971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106600" y="12193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096960" y="12193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916200" y="1676520"/>
            <a:ext cx="6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130720" y="190656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130720" y="12952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" descr=""/>
          <p:cNvPicPr/>
          <p:nvPr/>
        </p:nvPicPr>
        <p:blipFill>
          <a:blip r:embed="rId2"/>
          <a:srcRect l="-467" t="88521" r="29953" b="9794"/>
          <a:stretch/>
        </p:blipFill>
        <p:spPr>
          <a:xfrm>
            <a:off x="228600" y="4343400"/>
            <a:ext cx="3276720" cy="609480"/>
          </a:xfrm>
          <a:prstGeom prst="rect">
            <a:avLst/>
          </a:prstGeom>
          <a:ln w="0">
            <a:noFill/>
          </a:ln>
        </p:spPr>
      </p:pic>
      <p:sp>
        <p:nvSpPr>
          <p:cNvPr id="128" name=""/>
          <p:cNvSpPr/>
          <p:nvPr/>
        </p:nvSpPr>
        <p:spPr>
          <a:xfrm>
            <a:off x="914400" y="4559400"/>
            <a:ext cx="2895480" cy="22860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553080" y="6858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633000" y="60948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914400" y="914400"/>
            <a:ext cx="7315200" cy="2114640"/>
          </a:xfrm>
          <a:prstGeom prst="rect">
            <a:avLst/>
          </a:prstGeom>
          <a:ln w="0">
            <a:noFill/>
          </a:ln>
        </p:spPr>
      </p:pic>
      <p:sp>
        <p:nvSpPr>
          <p:cNvPr id="132" name=""/>
          <p:cNvSpPr/>
          <p:nvPr/>
        </p:nvSpPr>
        <p:spPr>
          <a:xfrm>
            <a:off x="4038480" y="914400"/>
            <a:ext cx="1600200" cy="38088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5486400" y="1905120"/>
            <a:ext cx="1600200" cy="22860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343400" y="2155680"/>
            <a:ext cx="1600200" cy="51120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267080" y="1295280"/>
            <a:ext cx="1600200" cy="53352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5105520" y="2666880"/>
            <a:ext cx="1143000" cy="22860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38320" y="228600"/>
            <a:ext cx="700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531 and lp_3625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28600" y="228600"/>
            <a:ext cx="914400" cy="38088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600200" y="228600"/>
            <a:ext cx="838080" cy="3808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2"/>
          <a:srcRect l="-467" t="84661" r="29953" b="10707"/>
          <a:stretch/>
        </p:blipFill>
        <p:spPr>
          <a:xfrm>
            <a:off x="304920" y="3860640"/>
            <a:ext cx="3276360" cy="1676520"/>
          </a:xfrm>
          <a:prstGeom prst="rect">
            <a:avLst/>
          </a:prstGeom>
          <a:ln w="0">
            <a:noFill/>
          </a:ln>
        </p:spPr>
      </p:pic>
      <p:sp>
        <p:nvSpPr>
          <p:cNvPr id="141" name=""/>
          <p:cNvSpPr/>
          <p:nvPr/>
        </p:nvSpPr>
        <p:spPr>
          <a:xfrm>
            <a:off x="448200" y="3429000"/>
            <a:ext cx="244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aci_selected_onestraineach.jp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600200" y="4635360"/>
            <a:ext cx="2209680" cy="22860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447920" y="4165560"/>
            <a:ext cx="2286000" cy="45720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625760" y="4013280"/>
            <a:ext cx="2209680" cy="1396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205440" y="6248520"/>
            <a:ext cx="567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pstream regions chosen on basis of similarity of moti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324480" y="41148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6404400" y="403848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332240" y="127332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105520" y="160020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410080" y="26668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127480" y="26668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6346800" y="4365720"/>
            <a:ext cx="0" cy="75960"/>
          </a:xfrm>
          <a:prstGeom prst="line">
            <a:avLst/>
          </a:prstGeom>
          <a:ln w="38160">
            <a:solidFill>
              <a:srgbClr val="ff66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105520" y="990720"/>
            <a:ext cx="0" cy="75960"/>
          </a:xfrm>
          <a:prstGeom prst="line">
            <a:avLst/>
          </a:prstGeom>
          <a:ln w="38160">
            <a:solidFill>
              <a:srgbClr val="ff66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105520" y="2133720"/>
            <a:ext cx="0" cy="75960"/>
          </a:xfrm>
          <a:prstGeom prst="line">
            <a:avLst/>
          </a:prstGeom>
          <a:ln w="38160">
            <a:solidFill>
              <a:srgbClr val="ff66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705720" y="1905120"/>
            <a:ext cx="0" cy="75960"/>
          </a:xfrm>
          <a:prstGeom prst="line">
            <a:avLst/>
          </a:prstGeom>
          <a:ln w="38160">
            <a:solidFill>
              <a:srgbClr val="ff66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5105520" y="2438280"/>
            <a:ext cx="0" cy="76320"/>
          </a:xfrm>
          <a:prstGeom prst="line">
            <a:avLst/>
          </a:prstGeom>
          <a:ln w="38160">
            <a:solidFill>
              <a:srgbClr val="ff66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" descr=""/>
          <p:cNvPicPr/>
          <p:nvPr/>
        </p:nvPicPr>
        <p:blipFill>
          <a:blip r:embed="rId1"/>
          <a:stretch/>
        </p:blipFill>
        <p:spPr>
          <a:xfrm>
            <a:off x="0" y="771480"/>
            <a:ext cx="9144000" cy="3495600"/>
          </a:xfrm>
          <a:prstGeom prst="rect">
            <a:avLst/>
          </a:prstGeom>
          <a:ln w="0">
            <a:noFill/>
          </a:ln>
        </p:spPr>
      </p:pic>
      <p:sp>
        <p:nvSpPr>
          <p:cNvPr id="158" name=""/>
          <p:cNvSpPr/>
          <p:nvPr/>
        </p:nvSpPr>
        <p:spPr>
          <a:xfrm>
            <a:off x="5638680" y="1914480"/>
            <a:ext cx="457200" cy="3049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H="1" flipV="1">
            <a:off x="6019560" y="1980720"/>
            <a:ext cx="1143000" cy="2514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7165440" y="4191120"/>
            <a:ext cx="137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RF call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96640" y="264960"/>
            <a:ext cx="5693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661 phylogeny, gene context and 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2" name="" descr=""/>
          <p:cNvPicPr/>
          <p:nvPr/>
        </p:nvPicPr>
        <p:blipFill>
          <a:blip r:embed="rId2"/>
          <a:srcRect l="-467" t="80520" r="29953" b="14849"/>
          <a:stretch/>
        </p:blipFill>
        <p:spPr>
          <a:xfrm>
            <a:off x="304920" y="4800600"/>
            <a:ext cx="3276360" cy="1676520"/>
          </a:xfrm>
          <a:prstGeom prst="rect">
            <a:avLst/>
          </a:prstGeom>
          <a:ln w="0">
            <a:noFill/>
          </a:ln>
        </p:spPr>
      </p:pic>
      <p:sp>
        <p:nvSpPr>
          <p:cNvPr id="163" name=""/>
          <p:cNvSpPr/>
          <p:nvPr/>
        </p:nvSpPr>
        <p:spPr>
          <a:xfrm>
            <a:off x="448200" y="4343400"/>
            <a:ext cx="244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aci_selected_onestraineach.jp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762120" y="5029200"/>
            <a:ext cx="2895480" cy="1219320"/>
          </a:xfrm>
          <a:prstGeom prst="rect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5715000" y="7714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715000" y="107640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715000" y="138096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5715000" y="166068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4660920" y="249876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715000" y="3057480"/>
            <a:ext cx="0" cy="7632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7086600" y="304920"/>
            <a:ext cx="0" cy="75960"/>
          </a:xfrm>
          <a:prstGeom prst="line">
            <a:avLst/>
          </a:prstGeom>
          <a:ln w="381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7166520" y="228600"/>
            <a:ext cx="184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ed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" descr=""/>
          <p:cNvPicPr/>
          <p:nvPr/>
        </p:nvPicPr>
        <p:blipFill>
          <a:blip r:embed="rId1"/>
          <a:stretch/>
        </p:blipFill>
        <p:spPr>
          <a:xfrm>
            <a:off x="395280" y="115920"/>
            <a:ext cx="4181400" cy="6610320"/>
          </a:xfrm>
          <a:prstGeom prst="rect">
            <a:avLst/>
          </a:prstGeom>
          <a:ln w="0">
            <a:noFill/>
          </a:ln>
        </p:spPr>
      </p:pic>
      <p:sp>
        <p:nvSpPr>
          <p:cNvPr id="174" name=""/>
          <p:cNvSpPr/>
          <p:nvPr/>
        </p:nvSpPr>
        <p:spPr>
          <a:xfrm>
            <a:off x="826920" y="2133720"/>
            <a:ext cx="5905800" cy="2447640"/>
          </a:xfrm>
          <a:prstGeom prst="rect">
            <a:avLst/>
          </a:prstGeom>
          <a:solidFill>
            <a:srgbClr val="ccffcc">
              <a:alpha val="30000"/>
            </a:srgbClr>
          </a:solidFill>
          <a:ln w="93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84360" y="1019160"/>
            <a:ext cx="8280360" cy="107964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793800" y="1773360"/>
            <a:ext cx="6370560" cy="322200"/>
          </a:xfrm>
          <a:prstGeom prst="rect">
            <a:avLst/>
          </a:prstGeom>
          <a:solidFill>
            <a:srgbClr val="ccffff">
              <a:alpha val="50000"/>
            </a:srgbClr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781200" y="1039680"/>
            <a:ext cx="6383160" cy="720720"/>
          </a:xfrm>
          <a:prstGeom prst="rect">
            <a:avLst/>
          </a:prstGeom>
          <a:solidFill>
            <a:srgbClr val="cc99ff">
              <a:alpha val="50000"/>
            </a:srgbClr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8002800" y="985680"/>
            <a:ext cx="99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84360" y="2146320"/>
            <a:ext cx="8280360" cy="3083040"/>
          </a:xfrm>
          <a:prstGeom prst="rect">
            <a:avLst/>
          </a:prstGeom>
          <a:noFill/>
          <a:ln w="93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8006040" y="2198520"/>
            <a:ext cx="990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7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p_34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258920" y="2433600"/>
            <a:ext cx="5473800" cy="432000"/>
          </a:xfrm>
          <a:prstGeom prst="rect">
            <a:avLst/>
          </a:prstGeom>
          <a:solidFill>
            <a:srgbClr val="ffff99">
              <a:alpha val="50000"/>
            </a:srgbClr>
          </a:solidFill>
          <a:ln w="93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189920" y="1700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7166160" y="1052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77000" y="189000"/>
            <a:ext cx="7189560" cy="368280"/>
          </a:xfrm>
          <a:prstGeom prst="rect">
            <a:avLst/>
          </a:prstGeom>
          <a:solidFill>
            <a:srgbClr val="ffffff">
              <a:alpha val="7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ylogeny of lp_3470 (lacR), lp_3479 and lp_3488 from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L. plantarum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29T10:35:05Z</dcterms:created>
  <dc:creator>cfrancke</dc:creator>
  <dc:description/>
  <dc:language>en-US</dc:language>
  <cp:lastModifiedBy>cfrancke</cp:lastModifiedBy>
  <dcterms:modified xsi:type="dcterms:W3CDTF">2007-07-19T12:41:22Z</dcterms:modified>
  <cp:revision>5</cp:revision>
  <dc:subject/>
  <dc:title>Slide 1</dc:title>
</cp:coreProperties>
</file>